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notesSlides/notesSlide1.xml" ContentType="application/vnd.openxmlformats-officedocument.presentationml.notesSlide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theme/theme1.xml" ContentType="application/vnd.openxmlformats-officedocument.theme+xml"/>
  <Override PartName="/ppt/theme/theme3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48" r:id="rId2"/>
  </p:sldMasterIdLst>
  <p:notesMasterIdLst>
    <p:notesMasterId r:id="rId4"/>
  </p:notesMasterIdLst>
  <p:sldIdLst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6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468" y="78"/>
      </p:cViewPr>
      <p:guideLst/>
    </p:cSldViewPr>
  </p:slideViewPr>
  <p:notesTextViewPr>
    <p:cViewPr>
      <p:scale>
        <a:sx n="1" d="1"/>
        <a:sy n="1" d="1"/>
      </p:scale>
      <p:origin x="0" y="-72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notesMaster" Target="notesMasters/notesMaster1.xml"/><Relationship Id="rId9" Type="http://schemas.openxmlformats.org/officeDocument/2006/relationships/customXml" Target="../customXml/item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5B3786-37C5-465A-A56C-F8DF0E8323E3}" type="datetimeFigureOut">
              <a:rPr lang="en-US"/>
              <a:t>5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170C02-0267-49B6-91E7-14B079EDC650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773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 panose="020F0502020204030204"/>
              </a:rPr>
              <a:t>The Pre-Training Assessment should be administered to training participants right after they sign up for a training, before giving them access to the videotaped didactic presentation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>
                <a:cs typeface="Calibri" panose="020F0502020204030204"/>
              </a:rPr>
              <a:t>It takes approximately 7 minutes to complete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 panose="020F0502020204030204"/>
              </a:rPr>
              <a:t>Provide the following direction: Please recommend edits you would suggest for this slide to make the content more inclusive and anti-racist. </a:t>
            </a:r>
          </a:p>
          <a:p>
            <a:endParaRPr lang="en-US" dirty="0">
              <a:cs typeface="Calibri" panose="020F050202020403020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9BBD22-414D-9643-AB67-6D0F763BBC7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4062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35013F-20EE-EF43-AA96-18A458D84E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654287-7B52-DF41-82E3-0BF37E393D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56210E-F805-9641-B2E4-8CFC38727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744517-477A-D344-8EA0-23855B61B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8DF070-8656-C745-AF28-79707A443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07253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41456-4D6E-D34C-9D46-E7B7640CF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69D5E6-CB58-0F4A-87CB-8D65D8CF75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2F7A40-83CF-374B-BA9D-6CCD99877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17551B-48A6-5F49-8699-310228CA3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313B1D-3407-594B-A41F-F45AAEF05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56318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A244F6-F5AE-A442-9269-33950A9133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EC2A3B-8E87-EB43-A0B0-1DC3AFBCB3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0B2442-9502-8842-801F-23E280D8F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FF1273-6B92-7745-A68F-2A6AB4500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47E24A-AFF4-8B4D-A3EE-DB027D0BA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17856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02836-019A-DC47-8D80-19389DDA16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306A3-480D-D147-93FE-F18E3406BF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645364-32AA-F84E-A4F8-F50C4B487D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9E0279-F942-0845-872E-0DA50CEFC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E18BFD-6E93-E94A-8E3A-60A29A70C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313C2F-D47F-A748-AB30-90BB8E66B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36661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8CEA7-8570-514C-9123-B3B37CBEE5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2013C6-BE1E-024D-A135-B49A7776D4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3274F0-828C-0E40-8B56-1E40B30446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356AC3-E253-EF42-ADF8-144F563E11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757640-451B-5342-A080-2889DD28FA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E0780D-4F2C-0944-82B1-5276C3334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BB72F1-DDEE-D54A-B54B-F26155EF0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FF37A3-785F-A647-8F96-B75F7E528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04594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10F14-1DE2-3F4C-835C-A11B6849A6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6CAF59-3D85-494E-BE5E-D6ACB952C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23808D-9C32-2B43-BD2A-633DA8259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97C80A-91B3-FE40-9117-06EF25D15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26101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60704F-C825-704D-B3C3-71AC4CF07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2ADF28-A1D0-1048-BF96-27D7846C3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2BB99D-D213-244E-BDBD-C4A42048C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91693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1B8B25-EBEC-8C4D-8D35-0C28174FD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73954E-E47F-C242-8FF0-E84E5AAA17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7BE82F-DFD3-994B-854F-0EF0C01B48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1996FB-CFDC-BB4F-B119-86BA191F2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98C9E9-354E-744F-AFB7-2B973F775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AC490B-4086-CB48-9540-0383552F3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153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E7C19-D705-3940-A4B5-CCCC531989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FFB00A-DB34-F443-8F23-D6336179E4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8393ED-D682-E541-81CD-EB92D0F145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0613FC-FC1B-AF4F-981F-CF8CDA4DD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66261B-2947-F741-B7EE-C24404BCB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397AE-E18C-7541-BDB7-48ABDDDD9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00090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C2C27-5A1C-3448-BC8A-D4C8493BE5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AD159D-D51B-A544-A012-B4FFE068AD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FE18AC-7970-FB46-B950-350E24F92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3373D9-9D7B-614E-8543-2FD9116F8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C48A8E-7E2E-6C4B-A770-4E38B0D18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84861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158C47-6763-4743-BEDF-EF2BCE3CE2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957C77-8970-AE4B-AFD6-F4613C9746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718759-A34C-4C4D-932E-183B0991C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95A0B0-E34D-764C-BFBC-047AD251B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0741AB-C11E-C447-BB6C-B441AB8FF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024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DA9485-4B7D-6B4E-813B-B9A18086A6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232BB5-E0FE-C742-877E-3AD764CDD6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6CBD04-0FDD-0C49-BF92-0700AD3741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42872-C4A5-4F42-9568-375E74164BC9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7A5F92-8220-A44B-9901-CD02C84220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0A927F-D9D7-F84A-A991-B2C723AEDB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24C267-60B7-0B44-9709-9AAD8BD59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64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45C5D0-A871-6A4C-82C0-473EB1E7EDAF}"/>
              </a:ext>
            </a:extLst>
          </p:cNvPr>
          <p:cNvSpPr txBox="1"/>
          <p:nvPr/>
        </p:nvSpPr>
        <p:spPr>
          <a:xfrm>
            <a:off x="472722" y="305489"/>
            <a:ext cx="10372034" cy="58477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3200"/>
              <a:t>Asthma</a:t>
            </a:r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5BB058-4277-0F4F-B16F-385C5301F407}"/>
              </a:ext>
            </a:extLst>
          </p:cNvPr>
          <p:cNvSpPr txBox="1"/>
          <p:nvPr/>
        </p:nvSpPr>
        <p:spPr>
          <a:xfrm>
            <a:off x="390530" y="712464"/>
            <a:ext cx="5961065" cy="63401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2400" dirty="0"/>
              <a:t>21yo Latino man presents with shortness of breath and increased work of breathing</a:t>
            </a:r>
          </a:p>
          <a:p>
            <a:endParaRPr lang="en-US" sz="2000" dirty="0">
              <a:cs typeface="Calibri" panose="020F0502020204030204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cs typeface="Calibri" panose="020F0502020204030204"/>
              </a:rPr>
              <a:t>Risk factors &amp; triggers</a:t>
            </a:r>
            <a:endParaRPr lang="en-US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>
                <a:cs typeface="Calibri" panose="020F0502020204030204"/>
              </a:rPr>
              <a:t>Black, Puerto Rican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>
                <a:cs typeface="Calibri" panose="020F0502020204030204"/>
              </a:rPr>
              <a:t>Environmental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>
                <a:cs typeface="Calibri" panose="020F0502020204030204"/>
              </a:rPr>
              <a:t>Viruses</a:t>
            </a:r>
          </a:p>
          <a:p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Exam: </a:t>
            </a:r>
            <a:endParaRPr lang="en-US" dirty="0">
              <a:cs typeface="Calibri" panose="020F0502020204030204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/>
              <a:t>Hypoxemia</a:t>
            </a:r>
            <a:endParaRPr lang="en-US" sz="1600" dirty="0">
              <a:cs typeface="Calibri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/>
              <a:t>Cyanosis</a:t>
            </a:r>
            <a:endParaRPr lang="en-US" sz="1600" dirty="0">
              <a:cs typeface="Calibri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/>
              <a:t>Increased work of breathing</a:t>
            </a:r>
            <a:endParaRPr lang="en-US" sz="1600" dirty="0">
              <a:cs typeface="Calibri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dirty="0">
              <a:cs typeface="Calibri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agnosi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/>
              <a:t>PFTs</a:t>
            </a:r>
            <a:endParaRPr lang="en-US" sz="1600" dirty="0">
              <a:cs typeface="Calibri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>
                <a:cs typeface="Calibri"/>
              </a:rPr>
              <a:t>CXR</a:t>
            </a:r>
          </a:p>
          <a:p>
            <a:endParaRPr lang="en-US" dirty="0">
              <a:cs typeface="Calibri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cs typeface="Calibri"/>
              </a:rPr>
              <a:t>Treatment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>
                <a:cs typeface="Calibri"/>
              </a:rPr>
              <a:t>Short acting beta agonist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600" dirty="0">
                <a:cs typeface="Calibri"/>
              </a:rPr>
              <a:t>NEJM study </a:t>
            </a:r>
            <a:r>
              <a:rPr lang="en-US" sz="1600">
                <a:cs typeface="Calibri"/>
              </a:rPr>
              <a:t>2019 Beasley, </a:t>
            </a:r>
            <a:r>
              <a:rPr lang="en-US" sz="1600" dirty="0">
                <a:cs typeface="Calibri"/>
              </a:rPr>
              <a:t>et al: budesonide-formoterol superior to albuterol as needed to prevent exacerbation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dirty="0">
              <a:cs typeface="Calibri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dirty="0">
              <a:cs typeface="Calibri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F9314A8-3413-E843-AD37-FA35350F6025}"/>
              </a:ext>
            </a:extLst>
          </p:cNvPr>
          <p:cNvGrpSpPr>
            <a:grpSpLocks noChangeAspect="1"/>
          </p:cNvGrpSpPr>
          <p:nvPr/>
        </p:nvGrpSpPr>
        <p:grpSpPr>
          <a:xfrm>
            <a:off x="6351595" y="2968326"/>
            <a:ext cx="5148072" cy="3444876"/>
            <a:chOff x="1543050" y="126"/>
            <a:chExt cx="9956617" cy="6662554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D206F63-9E9C-424D-9C71-D75F41F98D3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43050" y="126"/>
              <a:ext cx="9956617" cy="6662554"/>
              <a:chOff x="6747933" y="3428563"/>
              <a:chExt cx="4751734" cy="3234116"/>
            </a:xfrm>
          </p:grpSpPr>
          <p:pic>
            <p:nvPicPr>
              <p:cNvPr id="13" name="Picture 12" descr="Table&#10;&#10;Description automatically generated">
                <a:extLst>
                  <a:ext uri="{FF2B5EF4-FFF2-40B4-BE49-F238E27FC236}">
                    <a16:creationId xmlns:a16="http://schemas.microsoft.com/office/drawing/2014/main" id="{6CABD8F9-4715-CC4A-B610-5EC1CF825A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34" r="25229" b="258"/>
              <a:stretch/>
            </p:blipFill>
            <p:spPr>
              <a:xfrm>
                <a:off x="6747933" y="3428563"/>
                <a:ext cx="4751734" cy="3234116"/>
              </a:xfrm>
              <a:prstGeom prst="rect">
                <a:avLst/>
              </a:prstGeom>
            </p:spPr>
          </p:pic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BFF4B4B4-6CCF-4242-A9C2-75057A59A7BD}"/>
                  </a:ext>
                </a:extLst>
              </p:cNvPr>
              <p:cNvSpPr/>
              <p:nvPr/>
            </p:nvSpPr>
            <p:spPr>
              <a:xfrm>
                <a:off x="8642836" y="4026876"/>
                <a:ext cx="2586405" cy="21248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0E4D5381-B6D8-E74F-AC5D-D1FFABF97AAD}"/>
                </a:ext>
              </a:extLst>
            </p:cNvPr>
            <p:cNvSpPr/>
            <p:nvPr/>
          </p:nvSpPr>
          <p:spPr>
            <a:xfrm>
              <a:off x="3794760" y="1771650"/>
              <a:ext cx="4823460" cy="3314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>
                  <a:solidFill>
                    <a:schemeClr val="tx1"/>
                  </a:solidFill>
                </a:rPr>
                <a:t>Asthma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CDB52DEB-A99F-504C-87CF-22D85ED9E249}"/>
                </a:ext>
              </a:extLst>
            </p:cNvPr>
            <p:cNvSpPr/>
            <p:nvPr/>
          </p:nvSpPr>
          <p:spPr>
            <a:xfrm>
              <a:off x="2612863" y="723963"/>
              <a:ext cx="1237945" cy="33147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000" b="1" dirty="0">
                  <a:solidFill>
                    <a:schemeClr val="tx1"/>
                  </a:solidFill>
                </a:rPr>
                <a:t>Asian</a:t>
              </a: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9D4D4D69-043C-7184-C510-E4AFDD9D91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33262" y="334904"/>
            <a:ext cx="3476552" cy="26074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9346D8A-AABF-651B-D687-DDEE91773785}"/>
              </a:ext>
            </a:extLst>
          </p:cNvPr>
          <p:cNvSpPr txBox="1"/>
          <p:nvPr/>
        </p:nvSpPr>
        <p:spPr>
          <a:xfrm>
            <a:off x="10009814" y="444798"/>
            <a:ext cx="210218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mage by [James Heilman, MD], retrieved from: [https://</a:t>
            </a:r>
            <a:r>
              <a:rPr lang="en-US" sz="1200" dirty="0" err="1"/>
              <a:t>commons.wikimedia.org</a:t>
            </a:r>
            <a:r>
              <a:rPr lang="en-US" sz="1200" dirty="0"/>
              <a:t>/wiki/</a:t>
            </a:r>
            <a:r>
              <a:rPr lang="en-US" sz="1200" dirty="0" err="1"/>
              <a:t>File:Cynosis.JPG</a:t>
            </a:r>
            <a:r>
              <a:rPr lang="en-US" sz="1200" dirty="0"/>
              <a:t>] on [9/2/2022]. Creative Commons License associated: [https://</a:t>
            </a:r>
            <a:r>
              <a:rPr lang="en-US" sz="1200" dirty="0" err="1"/>
              <a:t>creativecommons.org</a:t>
            </a:r>
            <a:r>
              <a:rPr lang="en-US" sz="1200" dirty="0"/>
              <a:t>/licenses/by-</a:t>
            </a:r>
            <a:r>
              <a:rPr lang="en-US" sz="1200" dirty="0" err="1"/>
              <a:t>sa</a:t>
            </a:r>
            <a:r>
              <a:rPr lang="en-US" sz="1200" dirty="0"/>
              <a:t>/3.0/</a:t>
            </a:r>
            <a:r>
              <a:rPr lang="en-US" sz="1200" dirty="0" err="1"/>
              <a:t>deed.en</a:t>
            </a:r>
            <a:r>
              <a:rPr lang="en-US" sz="1200" dirty="0"/>
              <a:t>]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A965B7-F787-C8C9-890E-B357419872C0}"/>
              </a:ext>
            </a:extLst>
          </p:cNvPr>
          <p:cNvSpPr txBox="1"/>
          <p:nvPr/>
        </p:nvSpPr>
        <p:spPr>
          <a:xfrm>
            <a:off x="6768790" y="6556917"/>
            <a:ext cx="2348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aphic Author Owned</a:t>
            </a:r>
          </a:p>
        </p:txBody>
      </p:sp>
    </p:spTree>
    <p:extLst>
      <p:ext uri="{BB962C8B-B14F-4D97-AF65-F5344CB8AC3E}">
        <p14:creationId xmlns:p14="http://schemas.microsoft.com/office/powerpoint/2010/main" val="2819427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48978FD76C5A4FBE1B32C501F8FC88" ma:contentTypeVersion="17" ma:contentTypeDescription="Create a new document." ma:contentTypeScope="" ma:versionID="708c910a70887a4a99f8b67706587dc6">
  <xsd:schema xmlns:xsd="http://www.w3.org/2001/XMLSchema" xmlns:xs="http://www.w3.org/2001/XMLSchema" xmlns:p="http://schemas.microsoft.com/office/2006/metadata/properties" xmlns:ns2="35dab48a-e2c4-4028-ba67-19a1f1b4b8c7" xmlns:ns3="7d2e1451-08d6-4fd6-afba-a625a088b07a" targetNamespace="http://schemas.microsoft.com/office/2006/metadata/properties" ma:root="true" ma:fieldsID="d826f26a4ddf9fd24fe5f6ec1a443075" ns2:_="" ns3:_="">
    <xsd:import namespace="35dab48a-e2c4-4028-ba67-19a1f1b4b8c7"/>
    <xsd:import namespace="7d2e1451-08d6-4fd6-afba-a625a088b07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Statu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WorkflowStep" minOccurs="0"/>
                <xsd:element ref="ns2:MediaServiceLocation" minOccurs="0"/>
                <xsd:element ref="ns3:SharedWithUsers" minOccurs="0"/>
                <xsd:element ref="ns3:SharedWithDetails" minOccurs="0"/>
                <xsd:element ref="ns2:Detail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dab48a-e2c4-4028-ba67-19a1f1b4b8c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Status" ma:index="12" nillable="true" ma:displayName="Status" ma:description="File migration status" ma:format="Dropdown" ma:internalName="Status">
      <xsd:simpleType>
        <xsd:restriction base="dms:Text">
          <xsd:maxLength value="255"/>
        </xsd:restriction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cda1ba52-7d3b-4811-9808-5c9985ea513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WorkflowStep" ma:index="19" nillable="true" ma:displayName="Workflow Step" ma:description="The process relates to submissions at the following workflow step." ma:format="Dropdown" ma:internalName="WorkflowStep">
      <xsd:simpleType>
        <xsd:restriction base="dms:Choice">
          <xsd:enumeration value="Screening"/>
          <xsd:enumeration value="Peer Review"/>
          <xsd:enumeration value="Summary"/>
          <xsd:enumeration value="Preproduction"/>
          <xsd:enumeration value="Copyediting"/>
        </xsd:restriction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Details" ma:index="23" nillable="true" ma:displayName="Details" ma:format="Dropdown" ma:internalName="Details">
      <xsd:simpleType>
        <xsd:restriction base="dms:Note">
          <xsd:maxLength value="255"/>
        </xsd:restriction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2e1451-08d6-4fd6-afba-a625a088b07a" elementFormDefault="qualified">
    <xsd:import namespace="http://schemas.microsoft.com/office/2006/documentManagement/types"/>
    <xsd:import namespace="http://schemas.microsoft.com/office/infopath/2007/PartnerControls"/>
    <xsd:element name="TaxCatchAll" ma:index="15" nillable="true" ma:displayName="Taxonomy Catch All Column" ma:hidden="true" ma:list="{3a615f98-37e7-4a89-9b8a-052ff78f1e37}" ma:internalName="TaxCatchAll" ma:showField="CatchAllData" ma:web="7d2e1451-08d6-4fd6-afba-a625a088b07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6458636-21E7-4F93-9974-84B515BE964F}"/>
</file>

<file path=customXml/itemProps2.xml><?xml version="1.0" encoding="utf-8"?>
<ds:datastoreItem xmlns:ds="http://schemas.openxmlformats.org/officeDocument/2006/customXml" ds:itemID="{3D6A6370-FA5C-4F01-BDC7-F41194EDD6E4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04</TotalTime>
  <Words>176</Words>
  <Application>Microsoft Office PowerPoint</Application>
  <PresentationFormat>Widescreen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Jessica Zeidman</cp:lastModifiedBy>
  <cp:revision>111</cp:revision>
  <dcterms:created xsi:type="dcterms:W3CDTF">2013-07-15T20:26:40Z</dcterms:created>
  <dcterms:modified xsi:type="dcterms:W3CDTF">2023-05-02T03:05:06Z</dcterms:modified>
</cp:coreProperties>
</file>